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41" d="100"/>
          <a:sy n="41" d="100"/>
        </p:scale>
        <p:origin x="220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ennifer\Dropbox\Moore%20Lab\EGR1%20paper\Densitometries\Densitometri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nnifer\Dropbox\Moore%20Lab\MTS%20Assay\OVCAR8-NV-C5-cis-061815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ennifer\Dropbox\Moore%20Lab\MTS%20Assay\SKOV3-siEGR1-OVCAR8-pax-MTS-082615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 b="1">
                <a:solidFill>
                  <a:sysClr val="windowText" lastClr="000000"/>
                </a:solidFill>
              </a:rPr>
              <a:t>OVCAR8 Densitometr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H$1</c:f>
              <c:strCache>
                <c:ptCount val="1"/>
                <c:pt idx="0">
                  <c:v>cleaved PARP/β-tubulin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7!$G$2:$G$5</c:f>
              <c:strCache>
                <c:ptCount val="4"/>
                <c:pt idx="0">
                  <c:v>NV-Untrx</c:v>
                </c:pt>
                <c:pt idx="1">
                  <c:v>NV-cis</c:v>
                </c:pt>
                <c:pt idx="2">
                  <c:v>C5-Untrx</c:v>
                </c:pt>
                <c:pt idx="3">
                  <c:v>C5-cis</c:v>
                </c:pt>
              </c:strCache>
            </c:strRef>
          </c:cat>
          <c:val>
            <c:numRef>
              <c:f>Sheet7!$H$2:$H$5</c:f>
              <c:numCache>
                <c:formatCode>General</c:formatCode>
                <c:ptCount val="4"/>
                <c:pt idx="0">
                  <c:v>1.7821965131004913</c:v>
                </c:pt>
                <c:pt idx="1">
                  <c:v>5.2918109849891746</c:v>
                </c:pt>
                <c:pt idx="2">
                  <c:v>1</c:v>
                </c:pt>
                <c:pt idx="3">
                  <c:v>1.312704333347948</c:v>
                </c:pt>
              </c:numCache>
            </c:numRef>
          </c:val>
        </c:ser>
        <c:ser>
          <c:idx val="1"/>
          <c:order val="1"/>
          <c:tx>
            <c:strRef>
              <c:f>Sheet7!$I$1</c:f>
              <c:strCache>
                <c:ptCount val="1"/>
                <c:pt idx="0">
                  <c:v>PARP/β-tubuli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7!$G$2:$G$5</c:f>
              <c:strCache>
                <c:ptCount val="4"/>
                <c:pt idx="0">
                  <c:v>NV-Untrx</c:v>
                </c:pt>
                <c:pt idx="1">
                  <c:v>NV-cis</c:v>
                </c:pt>
                <c:pt idx="2">
                  <c:v>C5-Untrx</c:v>
                </c:pt>
                <c:pt idx="3">
                  <c:v>C5-cis</c:v>
                </c:pt>
              </c:strCache>
            </c:strRef>
          </c:cat>
          <c:val>
            <c:numRef>
              <c:f>Sheet7!$I$2:$I$5</c:f>
              <c:numCache>
                <c:formatCode>General</c:formatCode>
                <c:ptCount val="4"/>
                <c:pt idx="0">
                  <c:v>2.198889126138857</c:v>
                </c:pt>
                <c:pt idx="1">
                  <c:v>1.5634960914031795</c:v>
                </c:pt>
                <c:pt idx="2">
                  <c:v>1.9867961051531753</c:v>
                </c:pt>
                <c:pt idx="3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830808"/>
        <c:axId val="424836296"/>
      </c:barChart>
      <c:catAx>
        <c:axId val="424830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836296"/>
        <c:crosses val="autoZero"/>
        <c:auto val="1"/>
        <c:lblAlgn val="ctr"/>
        <c:lblOffset val="100"/>
        <c:noMultiLvlLbl val="0"/>
      </c:catAx>
      <c:valAx>
        <c:axId val="4248362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Relative Band D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830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 b="1" dirty="0" err="1" smtClean="0">
                <a:solidFill>
                  <a:sysClr val="windowText" lastClr="000000"/>
                </a:solidFill>
              </a:rPr>
              <a:t>OVCAR8</a:t>
            </a:r>
            <a:r>
              <a:rPr lang="en-US" sz="1400" b="1" dirty="0">
                <a:solidFill>
                  <a:sysClr val="windowText" lastClr="000000"/>
                </a:solidFill>
              </a:rPr>
              <a:t>:</a:t>
            </a:r>
            <a:r>
              <a:rPr lang="en-US" sz="1400" b="1" baseline="0" dirty="0" smtClean="0">
                <a:solidFill>
                  <a:sysClr val="windowText" lastClr="000000"/>
                </a:solidFill>
              </a:rPr>
              <a:t> 24 h </a:t>
            </a:r>
            <a:r>
              <a:rPr lang="en-US" sz="1400" b="1" baseline="0" dirty="0">
                <a:solidFill>
                  <a:sysClr val="windowText" lastClr="000000"/>
                </a:solidFill>
              </a:rPr>
              <a:t>Cisplatin</a:t>
            </a:r>
            <a:endParaRPr lang="en-US" sz="1400" b="1" dirty="0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5</c:f>
              <c:strCache>
                <c:ptCount val="1"/>
                <c:pt idx="0">
                  <c:v>NV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D$16:$D$20</c:f>
                <c:numCache>
                  <c:formatCode>General</c:formatCode>
                  <c:ptCount val="5"/>
                  <c:pt idx="0">
                    <c:v>4.7945205479452104</c:v>
                  </c:pt>
                  <c:pt idx="1">
                    <c:v>0.69750010577714527</c:v>
                  </c:pt>
                  <c:pt idx="2">
                    <c:v>3.0828963623331984</c:v>
                  </c:pt>
                  <c:pt idx="3">
                    <c:v>1.3761903592104339</c:v>
                  </c:pt>
                  <c:pt idx="4">
                    <c:v>0.22831050228310523</c:v>
                  </c:pt>
                </c:numCache>
              </c:numRef>
            </c:plus>
            <c:minus>
              <c:numRef>
                <c:f>Sheet1!$D$16:$D$20</c:f>
                <c:numCache>
                  <c:formatCode>General</c:formatCode>
                  <c:ptCount val="5"/>
                  <c:pt idx="0">
                    <c:v>4.7945205479452104</c:v>
                  </c:pt>
                  <c:pt idx="1">
                    <c:v>0.69750010577714527</c:v>
                  </c:pt>
                  <c:pt idx="2">
                    <c:v>3.0828963623331984</c:v>
                  </c:pt>
                  <c:pt idx="3">
                    <c:v>1.3761903592104339</c:v>
                  </c:pt>
                  <c:pt idx="4">
                    <c:v>0.22831050228310523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A$16:$A$20</c:f>
              <c:numCache>
                <c:formatCode>General</c:formatCode>
                <c:ptCount val="5"/>
                <c:pt idx="0">
                  <c:v>0</c:v>
                </c:pt>
                <c:pt idx="1">
                  <c:v>62.5</c:v>
                </c:pt>
                <c:pt idx="2">
                  <c:v>125</c:v>
                </c:pt>
                <c:pt idx="3">
                  <c:v>250</c:v>
                </c:pt>
                <c:pt idx="4">
                  <c:v>500</c:v>
                </c:pt>
              </c:numCache>
            </c:numRef>
          </c:cat>
          <c:val>
            <c:numRef>
              <c:f>Sheet1!$B$16:$B$20</c:f>
              <c:numCache>
                <c:formatCode>General</c:formatCode>
                <c:ptCount val="5"/>
                <c:pt idx="0">
                  <c:v>100</c:v>
                </c:pt>
                <c:pt idx="1">
                  <c:v>92.085235920852355</c:v>
                </c:pt>
                <c:pt idx="2">
                  <c:v>57.229832572298321</c:v>
                </c:pt>
                <c:pt idx="3">
                  <c:v>54.718417047184175</c:v>
                </c:pt>
                <c:pt idx="4">
                  <c:v>44.74885844748859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15</c:f>
              <c:strCache>
                <c:ptCount val="1"/>
                <c:pt idx="0">
                  <c:v>C5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E$16:$E$20</c:f>
                <c:numCache>
                  <c:formatCode>General</c:formatCode>
                  <c:ptCount val="5"/>
                  <c:pt idx="0">
                    <c:v>2.4119669124380345</c:v>
                  </c:pt>
                  <c:pt idx="1">
                    <c:v>11.642972950062269</c:v>
                  </c:pt>
                  <c:pt idx="2">
                    <c:v>1.5939066077199089</c:v>
                  </c:pt>
                  <c:pt idx="3">
                    <c:v>1.9951071337418695</c:v>
                  </c:pt>
                  <c:pt idx="4">
                    <c:v>3.2149550300006053</c:v>
                  </c:pt>
                </c:numCache>
              </c:numRef>
            </c:plus>
            <c:minus>
              <c:numRef>
                <c:f>Sheet1!$E$16:$E$20</c:f>
                <c:numCache>
                  <c:formatCode>General</c:formatCode>
                  <c:ptCount val="5"/>
                  <c:pt idx="0">
                    <c:v>2.4119669124380345</c:v>
                  </c:pt>
                  <c:pt idx="1">
                    <c:v>11.642972950062269</c:v>
                  </c:pt>
                  <c:pt idx="2">
                    <c:v>1.5939066077199089</c:v>
                  </c:pt>
                  <c:pt idx="3">
                    <c:v>1.9951071337418695</c:v>
                  </c:pt>
                  <c:pt idx="4">
                    <c:v>3.2149550300006053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A$16:$A$20</c:f>
              <c:numCache>
                <c:formatCode>General</c:formatCode>
                <c:ptCount val="5"/>
                <c:pt idx="0">
                  <c:v>0</c:v>
                </c:pt>
                <c:pt idx="1">
                  <c:v>62.5</c:v>
                </c:pt>
                <c:pt idx="2">
                  <c:v>125</c:v>
                </c:pt>
                <c:pt idx="3">
                  <c:v>250</c:v>
                </c:pt>
                <c:pt idx="4">
                  <c:v>500</c:v>
                </c:pt>
              </c:numCache>
            </c:numRef>
          </c:cat>
          <c:val>
            <c:numRef>
              <c:f>Sheet1!$C$16:$C$20</c:f>
              <c:numCache>
                <c:formatCode>General</c:formatCode>
                <c:ptCount val="5"/>
                <c:pt idx="0">
                  <c:v>100</c:v>
                </c:pt>
                <c:pt idx="1">
                  <c:v>99.474789915966412</c:v>
                </c:pt>
                <c:pt idx="2">
                  <c:v>70.168067226890756</c:v>
                </c:pt>
                <c:pt idx="3">
                  <c:v>67.64705882352942</c:v>
                </c:pt>
                <c:pt idx="4">
                  <c:v>54.72689075630252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24829632"/>
        <c:axId val="424846096"/>
      </c:lineChart>
      <c:catAx>
        <c:axId val="424829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Concentration [µM]</a:t>
                </a:r>
              </a:p>
            </c:rich>
          </c:tx>
          <c:layout>
            <c:manualLayout>
              <c:xMode val="edge"/>
              <c:yMode val="edge"/>
              <c:x val="0.37021574992841433"/>
              <c:y val="0.8043255846637573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846096"/>
        <c:crosses val="autoZero"/>
        <c:auto val="1"/>
        <c:lblAlgn val="ctr"/>
        <c:lblOffset val="100"/>
        <c:noMultiLvlLbl val="0"/>
      </c:catAx>
      <c:valAx>
        <c:axId val="424846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% Surviv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829632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</a:rPr>
              <a:t>OVCAR8</a:t>
            </a:r>
            <a:r>
              <a:rPr lang="en-US" b="1" baseline="0">
                <a:solidFill>
                  <a:sysClr val="windowText" lastClr="000000"/>
                </a:solidFill>
              </a:rPr>
              <a:t>: 48 h Paclitaxel</a:t>
            </a:r>
            <a:endParaRPr lang="en-US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B$15</c:f>
              <c:strCache>
                <c:ptCount val="1"/>
                <c:pt idx="0">
                  <c:v>NV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H$2:$H$6</c:f>
                <c:numCache>
                  <c:formatCode>General</c:formatCode>
                  <c:ptCount val="5"/>
                  <c:pt idx="0">
                    <c:v>2.2371640705865654</c:v>
                  </c:pt>
                  <c:pt idx="1">
                    <c:v>3.8010878856037551</c:v>
                  </c:pt>
                  <c:pt idx="2">
                    <c:v>1.4574465540201575</c:v>
                  </c:pt>
                  <c:pt idx="3">
                    <c:v>2.1019593127071903</c:v>
                  </c:pt>
                  <c:pt idx="4">
                    <c:v>1.2705724489170862</c:v>
                  </c:pt>
                </c:numCache>
              </c:numRef>
            </c:plus>
            <c:minus>
              <c:numRef>
                <c:f>Sheet2!$H$2:$H$6</c:f>
                <c:numCache>
                  <c:formatCode>General</c:formatCode>
                  <c:ptCount val="5"/>
                  <c:pt idx="0">
                    <c:v>2.2371640705865654</c:v>
                  </c:pt>
                  <c:pt idx="1">
                    <c:v>3.8010878856037551</c:v>
                  </c:pt>
                  <c:pt idx="2">
                    <c:v>1.4574465540201575</c:v>
                  </c:pt>
                  <c:pt idx="3">
                    <c:v>2.1019593127071903</c:v>
                  </c:pt>
                  <c:pt idx="4">
                    <c:v>1.27057244891708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A$16:$A$20</c:f>
              <c:numCache>
                <c:formatCode>General</c:formatCode>
                <c:ptCount val="5"/>
                <c:pt idx="0">
                  <c:v>0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cat>
          <c:val>
            <c:numRef>
              <c:f>Sheet2!$B$16:$B$20</c:f>
              <c:numCache>
                <c:formatCode>General</c:formatCode>
                <c:ptCount val="5"/>
                <c:pt idx="0">
                  <c:v>100</c:v>
                </c:pt>
                <c:pt idx="1">
                  <c:v>80.168931325743657</c:v>
                </c:pt>
                <c:pt idx="2">
                  <c:v>69.2985677561513</c:v>
                </c:pt>
                <c:pt idx="3">
                  <c:v>67.315460888725667</c:v>
                </c:pt>
                <c:pt idx="4">
                  <c:v>61.47631289019462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2!$C$15</c:f>
              <c:strCache>
                <c:ptCount val="1"/>
                <c:pt idx="0">
                  <c:v>C5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prstDash val="sysDash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H$9:$H$13</c:f>
                <c:numCache>
                  <c:formatCode>General</c:formatCode>
                  <c:ptCount val="5"/>
                  <c:pt idx="0">
                    <c:v>5.8767945438530367</c:v>
                  </c:pt>
                  <c:pt idx="1">
                    <c:v>8.5576526084531608</c:v>
                  </c:pt>
                  <c:pt idx="2">
                    <c:v>5.5271632339768075</c:v>
                  </c:pt>
                  <c:pt idx="3">
                    <c:v>3.4639927718274341</c:v>
                  </c:pt>
                  <c:pt idx="4">
                    <c:v>1.7796410465847881</c:v>
                  </c:pt>
                </c:numCache>
              </c:numRef>
            </c:plus>
            <c:minus>
              <c:numRef>
                <c:f>Sheet2!$H$9:$H$13</c:f>
                <c:numCache>
                  <c:formatCode>General</c:formatCode>
                  <c:ptCount val="5"/>
                  <c:pt idx="0">
                    <c:v>5.8767945438530367</c:v>
                  </c:pt>
                  <c:pt idx="1">
                    <c:v>8.5576526084531608</c:v>
                  </c:pt>
                  <c:pt idx="2">
                    <c:v>5.5271632339768075</c:v>
                  </c:pt>
                  <c:pt idx="3">
                    <c:v>3.4639927718274341</c:v>
                  </c:pt>
                  <c:pt idx="4">
                    <c:v>1.77964104658478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2!$A$16:$A$20</c:f>
              <c:numCache>
                <c:formatCode>General</c:formatCode>
                <c:ptCount val="5"/>
                <c:pt idx="0">
                  <c:v>0</c:v>
                </c:pt>
                <c:pt idx="1">
                  <c:v>0.625</c:v>
                </c:pt>
                <c:pt idx="2">
                  <c:v>1.25</c:v>
                </c:pt>
                <c:pt idx="3">
                  <c:v>2.5</c:v>
                </c:pt>
                <c:pt idx="4">
                  <c:v>5</c:v>
                </c:pt>
              </c:numCache>
            </c:numRef>
          </c:cat>
          <c:val>
            <c:numRef>
              <c:f>Sheet2!$C$16:$C$20</c:f>
              <c:numCache>
                <c:formatCode>General</c:formatCode>
                <c:ptCount val="5"/>
                <c:pt idx="0">
                  <c:v>100</c:v>
                </c:pt>
                <c:pt idx="1">
                  <c:v>92.491909385113274</c:v>
                </c:pt>
                <c:pt idx="2">
                  <c:v>79.029126213592235</c:v>
                </c:pt>
                <c:pt idx="3">
                  <c:v>74.563106796116514</c:v>
                </c:pt>
                <c:pt idx="4">
                  <c:v>65.24271844660194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24843744"/>
        <c:axId val="424817088"/>
      </c:lineChart>
      <c:catAx>
        <c:axId val="4248437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</a:rPr>
                  <a:t>Concentration </a:t>
                </a:r>
                <a:r>
                  <a:rPr lang="en-US" sz="1200" b="1" dirty="0" smtClean="0">
                    <a:solidFill>
                      <a:sysClr val="windowText" lastClr="000000"/>
                    </a:solidFill>
                  </a:rPr>
                  <a:t>[</a:t>
                </a:r>
                <a:r>
                  <a:rPr lang="en-US" sz="1200" b="1" dirty="0" err="1" smtClean="0">
                    <a:solidFill>
                      <a:sysClr val="windowText" lastClr="000000"/>
                    </a:solidFill>
                  </a:rPr>
                  <a:t>nM</a:t>
                </a:r>
                <a:r>
                  <a:rPr lang="en-US" sz="1200" b="1" dirty="0">
                    <a:solidFill>
                      <a:sysClr val="windowText" lastClr="000000"/>
                    </a:solidFill>
                  </a:rPr>
                  <a:t>]</a:t>
                </a:r>
              </a:p>
            </c:rich>
          </c:tx>
          <c:layout>
            <c:manualLayout>
              <c:xMode val="edge"/>
              <c:yMode val="edge"/>
              <c:x val="0.360842209838874"/>
              <c:y val="0.817359281608496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817088"/>
        <c:crosses val="autoZero"/>
        <c:auto val="1"/>
        <c:lblAlgn val="ctr"/>
        <c:lblOffset val="100"/>
        <c:noMultiLvlLbl val="0"/>
      </c:catAx>
      <c:valAx>
        <c:axId val="4248170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% Surviv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843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310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910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626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29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12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395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585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4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869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120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018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87A73-C84B-4328-AE2C-D1470BE3D5C0}" type="datetimeFigureOut">
              <a:rPr lang="en-US" smtClean="0"/>
              <a:t>3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96E-152D-4638-B132-23F53A3FEC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69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949262"/>
              </p:ext>
            </p:extLst>
          </p:nvPr>
        </p:nvGraphicFramePr>
        <p:xfrm>
          <a:off x="3849593" y="74001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2950727"/>
              </p:ext>
            </p:extLst>
          </p:nvPr>
        </p:nvGraphicFramePr>
        <p:xfrm>
          <a:off x="128702" y="74001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050" y="2950011"/>
            <a:ext cx="3789852" cy="1694336"/>
          </a:xfrm>
          <a:prstGeom prst="rect">
            <a:avLst/>
          </a:prstGeom>
        </p:spPr>
      </p:pic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8843776"/>
              </p:ext>
            </p:extLst>
          </p:nvPr>
        </p:nvGraphicFramePr>
        <p:xfrm>
          <a:off x="4070300" y="2846732"/>
          <a:ext cx="3436893" cy="27516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248216" y="185692"/>
            <a:ext cx="311304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20" b="1" dirty="0"/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28690" y="2990935"/>
            <a:ext cx="301686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20" b="1" dirty="0"/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922663" y="185692"/>
            <a:ext cx="295274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20" b="1" dirty="0"/>
              <a:t>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218102" y="3187151"/>
            <a:ext cx="316112" cy="34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2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372624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1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1</cp:revision>
  <dcterms:created xsi:type="dcterms:W3CDTF">2016-03-01T16:19:50Z</dcterms:created>
  <dcterms:modified xsi:type="dcterms:W3CDTF">2016-03-01T16:21:02Z</dcterms:modified>
</cp:coreProperties>
</file>